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4" r:id="rId2"/>
  </p:sldIdLst>
  <p:sldSz cx="23760113" cy="13698538"/>
  <p:notesSz cx="6858000" cy="9144000"/>
  <p:defaultTextStyle>
    <a:defPPr>
      <a:defRPr lang="ja-JP"/>
    </a:defPPr>
    <a:lvl1pPr marL="0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353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15" userDrawn="1">
          <p15:clr>
            <a:srgbClr val="A4A3A4"/>
          </p15:clr>
        </p15:guide>
        <p15:guide id="2" pos="6026" userDrawn="1">
          <p15:clr>
            <a:srgbClr val="A4A3A4"/>
          </p15:clr>
        </p15:guide>
        <p15:guide id="3" pos="2401" userDrawn="1">
          <p15:clr>
            <a:srgbClr val="A4A3A4"/>
          </p15:clr>
        </p15:guide>
        <p15:guide id="4" pos="11416" userDrawn="1">
          <p15:clr>
            <a:srgbClr val="A4A3A4"/>
          </p15:clr>
        </p15:guide>
        <p15:guide id="5" orient="horz" pos="7123" userDrawn="1">
          <p15:clr>
            <a:srgbClr val="A4A3A4"/>
          </p15:clr>
        </p15:guide>
        <p15:guide id="6" orient="horz" pos="917" userDrawn="1">
          <p15:clr>
            <a:srgbClr val="A4A3A4"/>
          </p15:clr>
        </p15:guide>
        <p15:guide id="7" pos="1224" userDrawn="1">
          <p15:clr>
            <a:srgbClr val="A4A3A4"/>
          </p15:clr>
        </p15:guide>
        <p15:guide id="8" pos="9031" userDrawn="1">
          <p15:clr>
            <a:srgbClr val="A4A3A4"/>
          </p15:clr>
        </p15:guide>
        <p15:guide id="9" orient="horz" pos="356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yama Izuma" initials="NI" lastIdx="22" clrIdx="0">
    <p:extLst>
      <p:ext uri="{19B8F6BF-5375-455C-9EA6-DF929625EA0E}">
        <p15:presenceInfo xmlns:p15="http://schemas.microsoft.com/office/powerpoint/2012/main" userId="57dc3945d2166f67" providerId="Windows Live"/>
      </p:ext>
    </p:extLst>
  </p:cmAuthor>
  <p:cmAuthor id="2" name="下嵜啓太郎" initials="下嵜啓太郎" lastIdx="8" clrIdx="1">
    <p:extLst>
      <p:ext uri="{19B8F6BF-5375-455C-9EA6-DF929625EA0E}">
        <p15:presenceInfo xmlns:p15="http://schemas.microsoft.com/office/powerpoint/2012/main" userId="759013536612368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52B38"/>
    <a:srgbClr val="005493"/>
    <a:srgbClr val="D9DEED"/>
    <a:srgbClr val="D9DE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17292A2E-F333-43FB-9621-5CBBE7FDCDCB}" styleName="淡色スタイル 2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11"/>
    <p:restoredTop sz="89439"/>
  </p:normalViewPr>
  <p:slideViewPr>
    <p:cSldViewPr snapToGrid="0" snapToObjects="1" showGuides="1">
      <p:cViewPr varScale="1">
        <p:scale>
          <a:sx n="69" d="100"/>
          <a:sy n="69" d="100"/>
        </p:scale>
        <p:origin x="1912" y="216"/>
      </p:cViewPr>
      <p:guideLst>
        <p:guide orient="horz" pos="4315"/>
        <p:guide pos="6026"/>
        <p:guide pos="2401"/>
        <p:guide pos="11416"/>
        <p:guide orient="horz" pos="7123"/>
        <p:guide orient="horz" pos="917"/>
        <p:guide pos="1224"/>
        <p:guide pos="9031"/>
        <p:guide orient="horz" pos="356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36AEA-D790-F74D-BC9D-BF7A4DB89FE8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752475" y="1143000"/>
            <a:ext cx="5353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412144-BE04-BB46-BAF5-2B46214D0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2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1pPr>
    <a:lvl2pPr marL="89899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2pPr>
    <a:lvl3pPr marL="1797985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3pPr>
    <a:lvl4pPr marL="269697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4pPr>
    <a:lvl5pPr marL="359596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5pPr>
    <a:lvl6pPr marL="4494962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6pPr>
    <a:lvl7pPr marL="5393954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7pPr>
    <a:lvl8pPr marL="6292947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8pPr>
    <a:lvl9pPr marL="7191939" algn="l" defTabSz="1797985" rtl="0" eaLnBrk="1" latinLnBrk="0" hangingPunct="1">
      <a:defRPr kumimoji="1" sz="236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b="0" dirty="0"/>
              <a:t>Figure 2. </a:t>
            </a:r>
            <a:r>
              <a:rPr kumimoji="1" lang="en-US" altLang="ja-JP" sz="236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Kaplan–Meier estimates of overall survival (a), progression-free survival (b), and post-progression survival (c).</a:t>
            </a:r>
            <a:r>
              <a:rPr lang="ja-JP" altLang="ja-JP">
                <a:effectLst/>
              </a:rPr>
              <a:t> </a:t>
            </a:r>
            <a:endParaRPr kumimoji="1" lang="ja-JP" altLang="en-US" b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0412144-BE04-BB46-BAF5-2B46214D041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2001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5245413-6788-2B4C-9373-C47D59752E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970014" y="2241868"/>
            <a:ext cx="17820085" cy="4769121"/>
          </a:xfrm>
        </p:spPr>
        <p:txBody>
          <a:bodyPr anchor="b"/>
          <a:lstStyle>
            <a:lvl1pPr algn="ctr"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E7B1C56-EA5A-6C43-96D4-E0D7C48A6C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970014" y="7194904"/>
            <a:ext cx="17820085" cy="3307308"/>
          </a:xfrm>
        </p:spPr>
        <p:txBody>
          <a:bodyPr/>
          <a:lstStyle>
            <a:lvl1pPr marL="0" indent="0" algn="ctr">
              <a:buNone/>
              <a:defRPr sz="4677"/>
            </a:lvl1pPr>
            <a:lvl2pPr marL="890991" indent="0" algn="ctr">
              <a:buNone/>
              <a:defRPr sz="3898"/>
            </a:lvl2pPr>
            <a:lvl3pPr marL="1781983" indent="0" algn="ctr">
              <a:buNone/>
              <a:defRPr sz="3508"/>
            </a:lvl3pPr>
            <a:lvl4pPr marL="2672974" indent="0" algn="ctr">
              <a:buNone/>
              <a:defRPr sz="3118"/>
            </a:lvl4pPr>
            <a:lvl5pPr marL="3563965" indent="0" algn="ctr">
              <a:buNone/>
              <a:defRPr sz="3118"/>
            </a:lvl5pPr>
            <a:lvl6pPr marL="4454957" indent="0" algn="ctr">
              <a:buNone/>
              <a:defRPr sz="3118"/>
            </a:lvl6pPr>
            <a:lvl7pPr marL="5345948" indent="0" algn="ctr">
              <a:buNone/>
              <a:defRPr sz="3118"/>
            </a:lvl7pPr>
            <a:lvl8pPr marL="6236940" indent="0" algn="ctr">
              <a:buNone/>
              <a:defRPr sz="3118"/>
            </a:lvl8pPr>
            <a:lvl9pPr marL="7127931" indent="0" algn="ctr">
              <a:buNone/>
              <a:defRPr sz="3118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25B8E8-48F3-FE45-A259-3007FF006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5450B2-DF15-204B-97B7-45AEB3FA4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499627-4C77-C042-9C33-49D598DD2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1880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28B38F-8A53-2146-822C-03F70A5F6C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0F4321-DD1D-AA4D-B2D5-6141788C05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AC2B8B-F3EA-EF47-9FD2-2E24AF4901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DA0236-8C8E-C445-AFE3-853F553D2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1D5E371-474A-9B4D-AED5-E2D9AA392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369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DF0D98B-D173-7249-A791-B2C39DFBDE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7003331" y="729320"/>
            <a:ext cx="5123274" cy="1160887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126A16C-A007-EA45-BD9A-C44C5D04AC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633508" y="729320"/>
            <a:ext cx="15072822" cy="1160887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84D828-113E-5741-A902-231E7BCC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18295A-419C-DB4A-8A51-AF976B52D9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B360BD-DD90-5747-B960-9AFCD1450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9311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0995B1-3E8A-5444-AD0D-8226CBF326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18AB91-6F55-8747-A37A-39E5967F71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DD9E7F-1BC1-C244-91AA-F4F9B250E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D9C338-FA7D-2C4A-A2DD-F0B6ED2D9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AEEED8-91AB-C74C-AEAC-F5042061A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728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D99A0D-4717-0A46-A966-1FEC849848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21133" y="3415128"/>
            <a:ext cx="20493097" cy="5698210"/>
          </a:xfrm>
        </p:spPr>
        <p:txBody>
          <a:bodyPr anchor="b"/>
          <a:lstStyle>
            <a:lvl1pPr>
              <a:defRPr sz="11693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C5AC2D5-DC25-FA40-9D90-B6CDE4477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21133" y="9167245"/>
            <a:ext cx="20493097" cy="2996554"/>
          </a:xfrm>
        </p:spPr>
        <p:txBody>
          <a:bodyPr/>
          <a:lstStyle>
            <a:lvl1pPr marL="0" indent="0">
              <a:buNone/>
              <a:defRPr sz="4677">
                <a:solidFill>
                  <a:schemeClr val="tx1">
                    <a:tint val="75000"/>
                  </a:schemeClr>
                </a:solidFill>
              </a:defRPr>
            </a:lvl1pPr>
            <a:lvl2pPr marL="890991" indent="0">
              <a:buNone/>
              <a:defRPr sz="3898">
                <a:solidFill>
                  <a:schemeClr val="tx1">
                    <a:tint val="75000"/>
                  </a:schemeClr>
                </a:solidFill>
              </a:defRPr>
            </a:lvl2pPr>
            <a:lvl3pPr marL="1781983" indent="0">
              <a:buNone/>
              <a:defRPr sz="3508">
                <a:solidFill>
                  <a:schemeClr val="tx1">
                    <a:tint val="75000"/>
                  </a:schemeClr>
                </a:solidFill>
              </a:defRPr>
            </a:lvl3pPr>
            <a:lvl4pPr marL="2672974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4pPr>
            <a:lvl5pPr marL="3563965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5pPr>
            <a:lvl6pPr marL="4454957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6pPr>
            <a:lvl7pPr marL="5345948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7pPr>
            <a:lvl8pPr marL="6236940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8pPr>
            <a:lvl9pPr marL="7127931" indent="0">
              <a:buNone/>
              <a:defRPr sz="311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C3CFF1-D0CE-524A-8AB7-32AADEFD0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2E143D-7B5A-1C48-91ED-9BEE292B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C8007CA-3D6A-1B44-9F59-0AE01DCC9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6591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FA2F9B-A514-1948-8ED6-5243ABD767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F3B15E9-0B49-A846-91C8-7B236CD0999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633508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39329E0-7B91-5946-8C5B-E5F6313B9E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2028557" y="3646601"/>
            <a:ext cx="10098048" cy="8691597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A2B9979-EC31-D941-B991-28A6E9A6F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4A55BD-BEC8-164F-B6C0-DBA18B3FC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8BC9221-85BA-2B49-AD36-C7A4CCB39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000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98DB9F-BD80-384A-B4F9-8C365683D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3" y="729325"/>
            <a:ext cx="20493097" cy="2647751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0354C6C-503D-FE4B-BCB6-963DAB6E21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6605" y="3358045"/>
            <a:ext cx="10051641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DFC96E3-8B8B-194C-AA50-4114777A9F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636605" y="5003772"/>
            <a:ext cx="10051641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F559E01-1877-9846-A63A-7C4A283013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12028557" y="3358045"/>
            <a:ext cx="10101143" cy="1645726"/>
          </a:xfrm>
        </p:spPr>
        <p:txBody>
          <a:bodyPr anchor="b"/>
          <a:lstStyle>
            <a:lvl1pPr marL="0" indent="0">
              <a:buNone/>
              <a:defRPr sz="4677" b="1"/>
            </a:lvl1pPr>
            <a:lvl2pPr marL="890991" indent="0">
              <a:buNone/>
              <a:defRPr sz="3898" b="1"/>
            </a:lvl2pPr>
            <a:lvl3pPr marL="1781983" indent="0">
              <a:buNone/>
              <a:defRPr sz="3508" b="1"/>
            </a:lvl3pPr>
            <a:lvl4pPr marL="2672974" indent="0">
              <a:buNone/>
              <a:defRPr sz="3118" b="1"/>
            </a:lvl4pPr>
            <a:lvl5pPr marL="3563965" indent="0">
              <a:buNone/>
              <a:defRPr sz="3118" b="1"/>
            </a:lvl5pPr>
            <a:lvl6pPr marL="4454957" indent="0">
              <a:buNone/>
              <a:defRPr sz="3118" b="1"/>
            </a:lvl6pPr>
            <a:lvl7pPr marL="5345948" indent="0">
              <a:buNone/>
              <a:defRPr sz="3118" b="1"/>
            </a:lvl7pPr>
            <a:lvl8pPr marL="6236940" indent="0">
              <a:buNone/>
              <a:defRPr sz="3118" b="1"/>
            </a:lvl8pPr>
            <a:lvl9pPr marL="7127931" indent="0">
              <a:buNone/>
              <a:defRPr sz="3118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D1606AD-078C-1A4C-82A9-69B000CDF2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12028557" y="5003772"/>
            <a:ext cx="10101143" cy="735979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5E94413-0DA0-604E-9AC6-13C80C991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30B1DA5-9646-5A48-93AA-0AE615C26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73432D8-7D56-2944-8FEA-04F30B372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596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F7D4ED-8889-1941-A39E-E6BCC173FB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FD3F1BF-5DBF-A640-95E3-BF2C523A32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592A65A-B585-0243-9CEE-F4C3DF6AA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101D531-BC13-EB4C-9687-45480C03D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027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3CAA49B-321E-6644-A136-D465EB4AE8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D96588C-8889-BF4F-BE08-241C641540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DA4F96-1DD4-CA4D-B323-6C0010528D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9215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86B29B-2BC8-FB48-B02F-1DF798A81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6E6EF6A-6A84-8347-A36E-EA1B9D8CC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>
              <a:defRPr sz="6236"/>
            </a:lvl1pPr>
            <a:lvl2pPr>
              <a:defRPr sz="5457"/>
            </a:lvl2pPr>
            <a:lvl3pPr>
              <a:defRPr sz="4677"/>
            </a:lvl3pPr>
            <a:lvl4pPr>
              <a:defRPr sz="3898"/>
            </a:lvl4pPr>
            <a:lvl5pPr>
              <a:defRPr sz="3898"/>
            </a:lvl5pPr>
            <a:lvl6pPr>
              <a:defRPr sz="3898"/>
            </a:lvl6pPr>
            <a:lvl7pPr>
              <a:defRPr sz="3898"/>
            </a:lvl7pPr>
            <a:lvl8pPr>
              <a:defRPr sz="3898"/>
            </a:lvl8pPr>
            <a:lvl9pPr>
              <a:defRPr sz="3898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F5E05A8-DCB7-814E-9F90-197C62983C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EE2390-36B8-4E4B-B50D-A32DDA256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BE7513-43CA-7948-9E0D-830153426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5E36DD5-DF0C-8648-BDEC-65AFF2FFD0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9921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742DBD-157F-BE49-88D3-986DDD12C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6606" y="913236"/>
            <a:ext cx="7663254" cy="3196326"/>
          </a:xfrm>
        </p:spPr>
        <p:txBody>
          <a:bodyPr anchor="b"/>
          <a:lstStyle>
            <a:lvl1pPr>
              <a:defRPr sz="6236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B2C6636-8F7E-FA44-AB01-2C1007A7F5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10101143" y="1972341"/>
            <a:ext cx="12028557" cy="9734841"/>
          </a:xfrm>
        </p:spPr>
        <p:txBody>
          <a:bodyPr/>
          <a:lstStyle>
            <a:lvl1pPr marL="0" indent="0">
              <a:buNone/>
              <a:defRPr sz="6236"/>
            </a:lvl1pPr>
            <a:lvl2pPr marL="890991" indent="0">
              <a:buNone/>
              <a:defRPr sz="5457"/>
            </a:lvl2pPr>
            <a:lvl3pPr marL="1781983" indent="0">
              <a:buNone/>
              <a:defRPr sz="4677"/>
            </a:lvl3pPr>
            <a:lvl4pPr marL="2672974" indent="0">
              <a:buNone/>
              <a:defRPr sz="3898"/>
            </a:lvl4pPr>
            <a:lvl5pPr marL="3563965" indent="0">
              <a:buNone/>
              <a:defRPr sz="3898"/>
            </a:lvl5pPr>
            <a:lvl6pPr marL="4454957" indent="0">
              <a:buNone/>
              <a:defRPr sz="3898"/>
            </a:lvl6pPr>
            <a:lvl7pPr marL="5345948" indent="0">
              <a:buNone/>
              <a:defRPr sz="3898"/>
            </a:lvl7pPr>
            <a:lvl8pPr marL="6236940" indent="0">
              <a:buNone/>
              <a:defRPr sz="3898"/>
            </a:lvl8pPr>
            <a:lvl9pPr marL="7127931" indent="0">
              <a:buNone/>
              <a:defRPr sz="3898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63BC946-7D0D-994A-A1DD-7ED3C02B97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636606" y="4109561"/>
            <a:ext cx="7663254" cy="7613471"/>
          </a:xfrm>
        </p:spPr>
        <p:txBody>
          <a:bodyPr/>
          <a:lstStyle>
            <a:lvl1pPr marL="0" indent="0">
              <a:buNone/>
              <a:defRPr sz="3118"/>
            </a:lvl1pPr>
            <a:lvl2pPr marL="890991" indent="0">
              <a:buNone/>
              <a:defRPr sz="2728"/>
            </a:lvl2pPr>
            <a:lvl3pPr marL="1781983" indent="0">
              <a:buNone/>
              <a:defRPr sz="2339"/>
            </a:lvl3pPr>
            <a:lvl4pPr marL="2672974" indent="0">
              <a:buNone/>
              <a:defRPr sz="1949"/>
            </a:lvl4pPr>
            <a:lvl5pPr marL="3563965" indent="0">
              <a:buNone/>
              <a:defRPr sz="1949"/>
            </a:lvl5pPr>
            <a:lvl6pPr marL="4454957" indent="0">
              <a:buNone/>
              <a:defRPr sz="1949"/>
            </a:lvl6pPr>
            <a:lvl7pPr marL="5345948" indent="0">
              <a:buNone/>
              <a:defRPr sz="1949"/>
            </a:lvl7pPr>
            <a:lvl8pPr marL="6236940" indent="0">
              <a:buNone/>
              <a:defRPr sz="1949"/>
            </a:lvl8pPr>
            <a:lvl9pPr marL="7127931" indent="0">
              <a:buNone/>
              <a:defRPr sz="1949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23FF658-7A1C-0546-A39F-B376438F3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4196D-1171-3B4A-BAE1-6B6D8949F670}" type="datetimeFigureOut">
              <a:rPr kumimoji="1" lang="ja-JP" altLang="en-US" smtClean="0"/>
              <a:t>2021/6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872B273-AC43-AD46-BC7E-134FD309E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C5CEFA7-62A9-0A49-A839-2FAA545FE0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FE01E6-B555-7547-BEFB-252F8AE841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532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C82FAC-8691-D148-8E09-B49F46EBD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3508" y="729325"/>
            <a:ext cx="20493097" cy="2647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436E9F-9649-D64D-83CB-0D39C8F1AA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633508" y="3646601"/>
            <a:ext cx="20493097" cy="869159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0AFE54B-F4D3-494D-9F02-C020FF4B3E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633508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6C04196D-1171-3B4A-BAE1-6B6D8949F670}" type="datetimeFigureOut">
              <a:rPr lang="ja-JP" altLang="en-US" smtClean="0"/>
              <a:pPr/>
              <a:t>2021/6/17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A2CF07-A504-0E44-B83D-839D090A7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7870538" y="12696520"/>
            <a:ext cx="8019038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89E7CF3-FE54-2441-8A09-BA3C3D0A6E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6780580" y="12696520"/>
            <a:ext cx="5346025" cy="72932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39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lvl1pPr>
          </a:lstStyle>
          <a:p>
            <a:fld id="{97FE01E6-B555-7547-BEFB-252F8AE8412B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59875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781983" rtl="0" eaLnBrk="1" latinLnBrk="0" hangingPunct="1">
        <a:lnSpc>
          <a:spcPct val="90000"/>
        </a:lnSpc>
        <a:spcBef>
          <a:spcPct val="0"/>
        </a:spcBef>
        <a:buNone/>
        <a:defRPr kumimoji="1" sz="8575" b="1" kern="1200">
          <a:solidFill>
            <a:schemeClr val="accent4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</p:titleStyle>
    <p:bodyStyle>
      <a:lvl1pPr marL="445496" indent="-445496" algn="l" defTabSz="1781983" rtl="0" eaLnBrk="1" latinLnBrk="0" hangingPunct="1">
        <a:lnSpc>
          <a:spcPct val="90000"/>
        </a:lnSpc>
        <a:spcBef>
          <a:spcPts val="1949"/>
        </a:spcBef>
        <a:buFont typeface="Arial" panose="020B0604020202020204" pitchFamily="34" charset="0"/>
        <a:buChar char="•"/>
        <a:defRPr kumimoji="1" sz="545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1pPr>
      <a:lvl2pPr marL="133648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4677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2pPr>
      <a:lvl3pPr marL="2227478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89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3pPr>
      <a:lvl4pPr marL="3118470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4pPr>
      <a:lvl5pPr marL="4009461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lvl5pPr>
      <a:lvl6pPr marL="4900452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791444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682435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573427" indent="-445496" algn="l" defTabSz="1781983" rtl="0" eaLnBrk="1" latinLnBrk="0" hangingPunct="1">
        <a:lnSpc>
          <a:spcPct val="90000"/>
        </a:lnSpc>
        <a:spcBef>
          <a:spcPts val="974"/>
        </a:spcBef>
        <a:buFont typeface="Arial" panose="020B0604020202020204" pitchFamily="34" charset="0"/>
        <a:buChar char="•"/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1pPr>
      <a:lvl2pPr marL="89099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2pPr>
      <a:lvl3pPr marL="1781983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3pPr>
      <a:lvl4pPr marL="2672974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4pPr>
      <a:lvl5pPr marL="3563965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5pPr>
      <a:lvl6pPr marL="4454957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6pPr>
      <a:lvl7pPr marL="5345948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7pPr>
      <a:lvl8pPr marL="6236940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8pPr>
      <a:lvl9pPr marL="7127931" algn="l" defTabSz="1781983" rtl="0" eaLnBrk="1" latinLnBrk="0" hangingPunct="1">
        <a:defRPr kumimoji="1" sz="350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3758307-ADC8-BC4E-BF36-A2BD9EF7714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928" t="2577" r="3345" b="15389"/>
          <a:stretch/>
        </p:blipFill>
        <p:spPr>
          <a:xfrm>
            <a:off x="1943100" y="7429004"/>
            <a:ext cx="7355762" cy="4966254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3A198732-9658-5741-BBDC-4AA7923FD3D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942" t="2332" r="3427" b="16116"/>
          <a:stretch/>
        </p:blipFill>
        <p:spPr>
          <a:xfrm>
            <a:off x="11038214" y="677214"/>
            <a:ext cx="7358607" cy="4944909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86F85CB1-C263-FF4C-BE31-915AD79E6AA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5281" t="2190" r="3627" b="21718"/>
          <a:stretch/>
        </p:blipFill>
        <p:spPr>
          <a:xfrm>
            <a:off x="1943100" y="698012"/>
            <a:ext cx="7355764" cy="4585798"/>
          </a:xfrm>
          <a:prstGeom prst="rect">
            <a:avLst/>
          </a:prstGeom>
        </p:spPr>
      </p:pic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6A10756E-DC5B-D34E-970A-525FA47794E2}"/>
              </a:ext>
            </a:extLst>
          </p:cNvPr>
          <p:cNvSpPr txBox="1"/>
          <p:nvPr/>
        </p:nvSpPr>
        <p:spPr>
          <a:xfrm>
            <a:off x="1254821" y="78495"/>
            <a:ext cx="700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a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266" name="グループ化 265">
            <a:extLst>
              <a:ext uri="{FF2B5EF4-FFF2-40B4-BE49-F238E27FC236}">
                <a16:creationId xmlns:a16="http://schemas.microsoft.com/office/drawing/2014/main" id="{2BC59D47-C2F3-6442-B881-19523F52EC73}"/>
              </a:ext>
            </a:extLst>
          </p:cNvPr>
          <p:cNvGrpSpPr/>
          <p:nvPr/>
        </p:nvGrpSpPr>
        <p:grpSpPr>
          <a:xfrm>
            <a:off x="1179977" y="565970"/>
            <a:ext cx="8554801" cy="5685588"/>
            <a:chOff x="1179977" y="565970"/>
            <a:chExt cx="8554801" cy="5685588"/>
          </a:xfrm>
        </p:grpSpPr>
        <p:grpSp>
          <p:nvGrpSpPr>
            <p:cNvPr id="138" name="グループ化 137">
              <a:extLst>
                <a:ext uri="{FF2B5EF4-FFF2-40B4-BE49-F238E27FC236}">
                  <a16:creationId xmlns:a16="http://schemas.microsoft.com/office/drawing/2014/main" id="{1BA910F8-BC9D-034D-9CF2-7F24917BE191}"/>
                </a:ext>
              </a:extLst>
            </p:cNvPr>
            <p:cNvGrpSpPr/>
            <p:nvPr/>
          </p:nvGrpSpPr>
          <p:grpSpPr>
            <a:xfrm>
              <a:off x="1568817" y="735246"/>
              <a:ext cx="8165961" cy="5516312"/>
              <a:chOff x="1587536" y="728662"/>
              <a:chExt cx="8165961" cy="5516312"/>
            </a:xfrm>
          </p:grpSpPr>
          <p:grpSp>
            <p:nvGrpSpPr>
              <p:cNvPr id="145" name="グループ化 144">
                <a:extLst>
                  <a:ext uri="{FF2B5EF4-FFF2-40B4-BE49-F238E27FC236}">
                    <a16:creationId xmlns:a16="http://schemas.microsoft.com/office/drawing/2014/main" id="{04917469-1C71-8D46-86E9-53F40308B091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153" name="グループ化 152">
                  <a:extLst>
                    <a:ext uri="{FF2B5EF4-FFF2-40B4-BE49-F238E27FC236}">
                      <a16:creationId xmlns:a16="http://schemas.microsoft.com/office/drawing/2014/main" id="{263BE9C6-EBDA-FF48-9D09-13E0974EBFC7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160" name="直線コネクタ 159">
                    <a:extLst>
                      <a:ext uri="{FF2B5EF4-FFF2-40B4-BE49-F238E27FC236}">
                        <a16:creationId xmlns:a16="http://schemas.microsoft.com/office/drawing/2014/main" id="{AFF526C7-AF53-6B4E-B838-19EA7D8EFB41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1" name="直線コネクタ 160">
                    <a:extLst>
                      <a:ext uri="{FF2B5EF4-FFF2-40B4-BE49-F238E27FC236}">
                        <a16:creationId xmlns:a16="http://schemas.microsoft.com/office/drawing/2014/main" id="{B005D3CB-323F-2746-AF76-B30756D5E3C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直線コネクタ 161">
                    <a:extLst>
                      <a:ext uri="{FF2B5EF4-FFF2-40B4-BE49-F238E27FC236}">
                        <a16:creationId xmlns:a16="http://schemas.microsoft.com/office/drawing/2014/main" id="{E72AB36F-25BE-FF4D-A3B2-B81F7267C002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3" name="直線コネクタ 162">
                    <a:extLst>
                      <a:ext uri="{FF2B5EF4-FFF2-40B4-BE49-F238E27FC236}">
                        <a16:creationId xmlns:a16="http://schemas.microsoft.com/office/drawing/2014/main" id="{8AE3FD73-E2A8-B64B-8679-A01C4A31C317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直線コネクタ 163">
                    <a:extLst>
                      <a:ext uri="{FF2B5EF4-FFF2-40B4-BE49-F238E27FC236}">
                        <a16:creationId xmlns:a16="http://schemas.microsoft.com/office/drawing/2014/main" id="{0EE09C6B-7371-3241-955A-4D6A30575684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5" name="直線コネクタ 164">
                    <a:extLst>
                      <a:ext uri="{FF2B5EF4-FFF2-40B4-BE49-F238E27FC236}">
                        <a16:creationId xmlns:a16="http://schemas.microsoft.com/office/drawing/2014/main" id="{C37191DC-EEB6-D144-A4E2-2E7B71369E5C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直線コネクタ 165">
                    <a:extLst>
                      <a:ext uri="{FF2B5EF4-FFF2-40B4-BE49-F238E27FC236}">
                        <a16:creationId xmlns:a16="http://schemas.microsoft.com/office/drawing/2014/main" id="{208DF2BB-889B-2D4E-87AA-D7DAFC91B2C1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7" name="直線コネクタ 166">
                    <a:extLst>
                      <a:ext uri="{FF2B5EF4-FFF2-40B4-BE49-F238E27FC236}">
                        <a16:creationId xmlns:a16="http://schemas.microsoft.com/office/drawing/2014/main" id="{8B07448A-8C21-C446-87A2-7A9369824860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8" name="直線コネクタ 167">
                    <a:extLst>
                      <a:ext uri="{FF2B5EF4-FFF2-40B4-BE49-F238E27FC236}">
                        <a16:creationId xmlns:a16="http://schemas.microsoft.com/office/drawing/2014/main" id="{8DA4CE70-9496-A04A-ACF2-5FBDE2823420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直線コネクタ 168">
                    <a:extLst>
                      <a:ext uri="{FF2B5EF4-FFF2-40B4-BE49-F238E27FC236}">
                        <a16:creationId xmlns:a16="http://schemas.microsoft.com/office/drawing/2014/main" id="{7949BAA4-07EE-2A48-99DC-5BF613C83C6C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0" name="直線コネクタ 169">
                    <a:extLst>
                      <a:ext uri="{FF2B5EF4-FFF2-40B4-BE49-F238E27FC236}">
                        <a16:creationId xmlns:a16="http://schemas.microsoft.com/office/drawing/2014/main" id="{F1A79F23-EFAC-F149-8030-ABC7F66DB729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1" name="直線コネクタ 170">
                    <a:extLst>
                      <a:ext uri="{FF2B5EF4-FFF2-40B4-BE49-F238E27FC236}">
                        <a16:creationId xmlns:a16="http://schemas.microsoft.com/office/drawing/2014/main" id="{A5820388-34FB-484B-BE8A-A20663957AE8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54" name="グループ化 153">
                  <a:extLst>
                    <a:ext uri="{FF2B5EF4-FFF2-40B4-BE49-F238E27FC236}">
                      <a16:creationId xmlns:a16="http://schemas.microsoft.com/office/drawing/2014/main" id="{02A0B1C8-42D6-EF47-A22F-9EE8F0B6833B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155" name="直線コネクタ 154">
                    <a:extLst>
                      <a:ext uri="{FF2B5EF4-FFF2-40B4-BE49-F238E27FC236}">
                        <a16:creationId xmlns:a16="http://schemas.microsoft.com/office/drawing/2014/main" id="{0CBAA652-5151-664E-8E0D-56A5DAF66713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6" name="直線コネクタ 155">
                    <a:extLst>
                      <a:ext uri="{FF2B5EF4-FFF2-40B4-BE49-F238E27FC236}">
                        <a16:creationId xmlns:a16="http://schemas.microsoft.com/office/drawing/2014/main" id="{83FCA2C3-3B7F-EC44-A98F-70AD269E240D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7" name="直線コネクタ 156">
                    <a:extLst>
                      <a:ext uri="{FF2B5EF4-FFF2-40B4-BE49-F238E27FC236}">
                        <a16:creationId xmlns:a16="http://schemas.microsoft.com/office/drawing/2014/main" id="{99A23AD4-56FF-864C-BC8D-6F6463798705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8" name="直線コネクタ 157">
                    <a:extLst>
                      <a:ext uri="{FF2B5EF4-FFF2-40B4-BE49-F238E27FC236}">
                        <a16:creationId xmlns:a16="http://schemas.microsoft.com/office/drawing/2014/main" id="{A252045A-A553-8542-ABD8-3264BCA4D512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直線コネクタ 158">
                    <a:extLst>
                      <a:ext uri="{FF2B5EF4-FFF2-40B4-BE49-F238E27FC236}">
                        <a16:creationId xmlns:a16="http://schemas.microsoft.com/office/drawing/2014/main" id="{719A1B91-80CC-B74E-8827-C2D6B43E5C4D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46" name="グループ化 145">
                <a:extLst>
                  <a:ext uri="{FF2B5EF4-FFF2-40B4-BE49-F238E27FC236}">
                    <a16:creationId xmlns:a16="http://schemas.microsoft.com/office/drawing/2014/main" id="{4FE993E6-BAB0-764B-A632-AC177777FFEA}"/>
                  </a:ext>
                </a:extLst>
              </p:cNvPr>
              <p:cNvGrpSpPr/>
              <p:nvPr/>
            </p:nvGrpSpPr>
            <p:grpSpPr>
              <a:xfrm>
                <a:off x="1587536" y="5875641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147" name="テキスト ボックス 146">
                  <a:extLst>
                    <a:ext uri="{FF2B5EF4-FFF2-40B4-BE49-F238E27FC236}">
                      <a16:creationId xmlns:a16="http://schemas.microsoft.com/office/drawing/2014/main" id="{95BB4A61-7402-EB49-AF3F-BDD1AE8C087D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686D9CFF-D33B-E94B-9C1A-871532E7476C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テキスト ボックス 148">
                  <a:extLst>
                    <a:ext uri="{FF2B5EF4-FFF2-40B4-BE49-F238E27FC236}">
                      <a16:creationId xmlns:a16="http://schemas.microsoft.com/office/drawing/2014/main" id="{02541B7C-5333-D249-B8A1-EE802985ACA6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テキスト ボックス 149">
                  <a:extLst>
                    <a:ext uri="{FF2B5EF4-FFF2-40B4-BE49-F238E27FC236}">
                      <a16:creationId xmlns:a16="http://schemas.microsoft.com/office/drawing/2014/main" id="{068F7386-A08A-984A-9DA1-EBC0FDC29C27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テキスト ボックス 150">
                  <a:extLst>
                    <a:ext uri="{FF2B5EF4-FFF2-40B4-BE49-F238E27FC236}">
                      <a16:creationId xmlns:a16="http://schemas.microsoft.com/office/drawing/2014/main" id="{87678CB2-02AE-F746-BF6F-883789B3D7BA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E89C9113-5504-DB4A-85F8-9D9BE7773ED1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B686D297-DB16-8A46-8BB9-945F3CEED32B}"/>
                </a:ext>
              </a:extLst>
            </p:cNvPr>
            <p:cNvSpPr txBox="1"/>
            <p:nvPr/>
          </p:nvSpPr>
          <p:spPr>
            <a:xfrm>
              <a:off x="1180104" y="565970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E6BF56D2-C489-C445-8EC3-893E7FE84173}"/>
                </a:ext>
              </a:extLst>
            </p:cNvPr>
            <p:cNvSpPr txBox="1"/>
            <p:nvPr/>
          </p:nvSpPr>
          <p:spPr>
            <a:xfrm>
              <a:off x="1180104" y="1556215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E346741B-07BC-E54D-8806-3C65D9B9A940}"/>
                </a:ext>
              </a:extLst>
            </p:cNvPr>
            <p:cNvSpPr txBox="1"/>
            <p:nvPr/>
          </p:nvSpPr>
          <p:spPr>
            <a:xfrm>
              <a:off x="1179977" y="2546462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AE0CBCCE-9FC5-4E43-AF10-6A695031C3CB}"/>
                </a:ext>
              </a:extLst>
            </p:cNvPr>
            <p:cNvSpPr txBox="1"/>
            <p:nvPr/>
          </p:nvSpPr>
          <p:spPr>
            <a:xfrm>
              <a:off x="1179977" y="3536707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A7778F22-7E70-0248-80C7-C4255326CBC5}"/>
                </a:ext>
              </a:extLst>
            </p:cNvPr>
            <p:cNvSpPr txBox="1"/>
            <p:nvPr/>
          </p:nvSpPr>
          <p:spPr>
            <a:xfrm>
              <a:off x="1179977" y="4557695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504AD054-53C8-9241-82C4-F4946932D9C9}"/>
                </a:ext>
              </a:extLst>
            </p:cNvPr>
            <p:cNvSpPr txBox="1"/>
            <p:nvPr/>
          </p:nvSpPr>
          <p:spPr>
            <a:xfrm>
              <a:off x="1179977" y="5547940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752E5EC6-9E2F-324B-BEDE-EC09690E32A7}"/>
              </a:ext>
            </a:extLst>
          </p:cNvPr>
          <p:cNvSpPr txBox="1"/>
          <p:nvPr/>
        </p:nvSpPr>
        <p:spPr>
          <a:xfrm rot="16200000">
            <a:off x="219814" y="3059616"/>
            <a:ext cx="1872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38CBBE80-B118-A840-8228-1380AB600FC1}"/>
              </a:ext>
            </a:extLst>
          </p:cNvPr>
          <p:cNvSpPr txBox="1"/>
          <p:nvPr/>
        </p:nvSpPr>
        <p:spPr>
          <a:xfrm>
            <a:off x="4746649" y="6129338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4" name="表 173">
            <a:extLst>
              <a:ext uri="{FF2B5EF4-FFF2-40B4-BE49-F238E27FC236}">
                <a16:creationId xmlns:a16="http://schemas.microsoft.com/office/drawing/2014/main" id="{E90475DF-2450-E74D-85AA-DA48368B82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5143936"/>
              </p:ext>
            </p:extLst>
          </p:nvPr>
        </p:nvGraphicFramePr>
        <p:xfrm>
          <a:off x="4656850" y="728656"/>
          <a:ext cx="4841178" cy="11254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3726">
                  <a:extLst>
                    <a:ext uri="{9D8B030D-6E8A-4147-A177-3AD203B41FA5}">
                      <a16:colId xmlns:a16="http://schemas.microsoft.com/office/drawing/2014/main" val="1701326281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927374419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394682298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/N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39234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4/608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–17.9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262382"/>
                  </a:ext>
                </a:extLst>
              </a:tr>
            </a:tbl>
          </a:graphicData>
        </a:graphic>
      </p:graphicFrame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5702F312-3239-4544-B5C9-488592264C17}"/>
              </a:ext>
            </a:extLst>
          </p:cNvPr>
          <p:cNvSpPr txBox="1"/>
          <p:nvPr/>
        </p:nvSpPr>
        <p:spPr>
          <a:xfrm>
            <a:off x="937186" y="6215019"/>
            <a:ext cx="800219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No. </a:t>
            </a:r>
          </a:p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at risk</a:t>
            </a:r>
            <a:endParaRPr kumimoji="1"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8C4A7C4E-FD1B-9D4A-8602-621D8C5C4997}"/>
              </a:ext>
            </a:extLst>
          </p:cNvPr>
          <p:cNvSpPr txBox="1"/>
          <p:nvPr/>
        </p:nvSpPr>
        <p:spPr>
          <a:xfrm>
            <a:off x="1587536" y="6454784"/>
            <a:ext cx="749024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608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EF3967E2-7CDE-0D46-B1CA-48C287F713E4}"/>
              </a:ext>
            </a:extLst>
          </p:cNvPr>
          <p:cNvSpPr txBox="1"/>
          <p:nvPr/>
        </p:nvSpPr>
        <p:spPr>
          <a:xfrm>
            <a:off x="2970528" y="6454785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380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F20A060A-5329-3147-9DA8-BC72E21B7523}"/>
              </a:ext>
            </a:extLst>
          </p:cNvPr>
          <p:cNvSpPr txBox="1"/>
          <p:nvPr/>
        </p:nvSpPr>
        <p:spPr>
          <a:xfrm>
            <a:off x="4470413" y="6454785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179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93617D96-0C62-B946-B9E6-304F0BD4C5FD}"/>
              </a:ext>
            </a:extLst>
          </p:cNvPr>
          <p:cNvSpPr txBox="1"/>
          <p:nvPr/>
        </p:nvSpPr>
        <p:spPr>
          <a:xfrm>
            <a:off x="5916338" y="6454785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800E8F09-AC8E-054B-B080-8CB79A96C2BE}"/>
              </a:ext>
            </a:extLst>
          </p:cNvPr>
          <p:cNvSpPr txBox="1"/>
          <p:nvPr/>
        </p:nvSpPr>
        <p:spPr>
          <a:xfrm>
            <a:off x="7362263" y="6454785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8CC1D87B-FA8A-DE42-86DC-8E0896EB75AE}"/>
              </a:ext>
            </a:extLst>
          </p:cNvPr>
          <p:cNvSpPr txBox="1"/>
          <p:nvPr/>
        </p:nvSpPr>
        <p:spPr>
          <a:xfrm>
            <a:off x="8845652" y="6454785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5" name="グループ化 264">
            <a:extLst>
              <a:ext uri="{FF2B5EF4-FFF2-40B4-BE49-F238E27FC236}">
                <a16:creationId xmlns:a16="http://schemas.microsoft.com/office/drawing/2014/main" id="{A02CBFD9-95E4-D746-B462-C90826F6FC59}"/>
              </a:ext>
            </a:extLst>
          </p:cNvPr>
          <p:cNvGrpSpPr/>
          <p:nvPr/>
        </p:nvGrpSpPr>
        <p:grpSpPr>
          <a:xfrm>
            <a:off x="10291577" y="565970"/>
            <a:ext cx="8554801" cy="5685587"/>
            <a:chOff x="10291577" y="565970"/>
            <a:chExt cx="8554801" cy="5685587"/>
          </a:xfrm>
        </p:grpSpPr>
        <p:grpSp>
          <p:nvGrpSpPr>
            <p:cNvPr id="219" name="グループ化 218">
              <a:extLst>
                <a:ext uri="{FF2B5EF4-FFF2-40B4-BE49-F238E27FC236}">
                  <a16:creationId xmlns:a16="http://schemas.microsoft.com/office/drawing/2014/main" id="{B6BBD630-281F-9146-A076-28E7645FEBEF}"/>
                </a:ext>
              </a:extLst>
            </p:cNvPr>
            <p:cNvGrpSpPr/>
            <p:nvPr/>
          </p:nvGrpSpPr>
          <p:grpSpPr>
            <a:xfrm>
              <a:off x="10680417" y="735246"/>
              <a:ext cx="8165961" cy="5516311"/>
              <a:chOff x="1587536" y="728662"/>
              <a:chExt cx="8165961" cy="5516311"/>
            </a:xfrm>
          </p:grpSpPr>
          <p:grpSp>
            <p:nvGrpSpPr>
              <p:cNvPr id="226" name="グループ化 225">
                <a:extLst>
                  <a:ext uri="{FF2B5EF4-FFF2-40B4-BE49-F238E27FC236}">
                    <a16:creationId xmlns:a16="http://schemas.microsoft.com/office/drawing/2014/main" id="{4046DA21-A8DA-3B4B-A511-8C8D86BBF30F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234" name="グループ化 233">
                  <a:extLst>
                    <a:ext uri="{FF2B5EF4-FFF2-40B4-BE49-F238E27FC236}">
                      <a16:creationId xmlns:a16="http://schemas.microsoft.com/office/drawing/2014/main" id="{5EFDBE58-D55B-A343-8504-1B6A0F84F1D1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241" name="直線コネクタ 240">
                    <a:extLst>
                      <a:ext uri="{FF2B5EF4-FFF2-40B4-BE49-F238E27FC236}">
                        <a16:creationId xmlns:a16="http://schemas.microsoft.com/office/drawing/2014/main" id="{360FAD13-97E4-5E47-B32A-147B044608C1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2" name="直線コネクタ 241">
                    <a:extLst>
                      <a:ext uri="{FF2B5EF4-FFF2-40B4-BE49-F238E27FC236}">
                        <a16:creationId xmlns:a16="http://schemas.microsoft.com/office/drawing/2014/main" id="{9DD77772-23BA-E748-8E01-D3A5817750F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直線コネクタ 242">
                    <a:extLst>
                      <a:ext uri="{FF2B5EF4-FFF2-40B4-BE49-F238E27FC236}">
                        <a16:creationId xmlns:a16="http://schemas.microsoft.com/office/drawing/2014/main" id="{2C82F68D-8C95-F04C-AEDD-E92B934ED5AF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" name="直線コネクタ 243">
                    <a:extLst>
                      <a:ext uri="{FF2B5EF4-FFF2-40B4-BE49-F238E27FC236}">
                        <a16:creationId xmlns:a16="http://schemas.microsoft.com/office/drawing/2014/main" id="{6977A28C-EF2D-784E-93B0-56CBC8B490B5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" name="直線コネクタ 244">
                    <a:extLst>
                      <a:ext uri="{FF2B5EF4-FFF2-40B4-BE49-F238E27FC236}">
                        <a16:creationId xmlns:a16="http://schemas.microsoft.com/office/drawing/2014/main" id="{9443621D-199A-094A-A154-F6F42BF63E87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" name="直線コネクタ 245">
                    <a:extLst>
                      <a:ext uri="{FF2B5EF4-FFF2-40B4-BE49-F238E27FC236}">
                        <a16:creationId xmlns:a16="http://schemas.microsoft.com/office/drawing/2014/main" id="{E9398429-70CD-3448-AA30-555EC6475D58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" name="直線コネクタ 246">
                    <a:extLst>
                      <a:ext uri="{FF2B5EF4-FFF2-40B4-BE49-F238E27FC236}">
                        <a16:creationId xmlns:a16="http://schemas.microsoft.com/office/drawing/2014/main" id="{FE2CECA8-8712-FC44-A126-4B2EC431376F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" name="直線コネクタ 247">
                    <a:extLst>
                      <a:ext uri="{FF2B5EF4-FFF2-40B4-BE49-F238E27FC236}">
                        <a16:creationId xmlns:a16="http://schemas.microsoft.com/office/drawing/2014/main" id="{9C893E3D-368A-204B-A219-17BEF97095CE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" name="直線コネクタ 248">
                    <a:extLst>
                      <a:ext uri="{FF2B5EF4-FFF2-40B4-BE49-F238E27FC236}">
                        <a16:creationId xmlns:a16="http://schemas.microsoft.com/office/drawing/2014/main" id="{17DD7B89-D2FE-204F-B6B8-F82464B1AF45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" name="直線コネクタ 249">
                    <a:extLst>
                      <a:ext uri="{FF2B5EF4-FFF2-40B4-BE49-F238E27FC236}">
                        <a16:creationId xmlns:a16="http://schemas.microsoft.com/office/drawing/2014/main" id="{A139D50E-31DC-654B-968A-5C1896220D2E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1" name="直線コネクタ 250">
                    <a:extLst>
                      <a:ext uri="{FF2B5EF4-FFF2-40B4-BE49-F238E27FC236}">
                        <a16:creationId xmlns:a16="http://schemas.microsoft.com/office/drawing/2014/main" id="{CC09CC6B-5490-8848-8780-8EDE8A022004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2" name="直線コネクタ 251">
                    <a:extLst>
                      <a:ext uri="{FF2B5EF4-FFF2-40B4-BE49-F238E27FC236}">
                        <a16:creationId xmlns:a16="http://schemas.microsoft.com/office/drawing/2014/main" id="{FD9ADFA3-D48D-0840-81DA-58F45AFB7943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5" name="グループ化 234">
                  <a:extLst>
                    <a:ext uri="{FF2B5EF4-FFF2-40B4-BE49-F238E27FC236}">
                      <a16:creationId xmlns:a16="http://schemas.microsoft.com/office/drawing/2014/main" id="{2AC426C1-B91C-704F-B707-56C597668857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236" name="直線コネクタ 235">
                    <a:extLst>
                      <a:ext uri="{FF2B5EF4-FFF2-40B4-BE49-F238E27FC236}">
                        <a16:creationId xmlns:a16="http://schemas.microsoft.com/office/drawing/2014/main" id="{8AFDEDCC-18EB-4047-81E3-FD175B4D061B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7" name="直線コネクタ 236">
                    <a:extLst>
                      <a:ext uri="{FF2B5EF4-FFF2-40B4-BE49-F238E27FC236}">
                        <a16:creationId xmlns:a16="http://schemas.microsoft.com/office/drawing/2014/main" id="{EC2A9CA5-6D61-444F-BD24-CC9E02707DE7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8" name="直線コネクタ 237">
                    <a:extLst>
                      <a:ext uri="{FF2B5EF4-FFF2-40B4-BE49-F238E27FC236}">
                        <a16:creationId xmlns:a16="http://schemas.microsoft.com/office/drawing/2014/main" id="{98C9EE9C-64EB-AE42-9C98-D863E82F362B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9" name="直線コネクタ 238">
                    <a:extLst>
                      <a:ext uri="{FF2B5EF4-FFF2-40B4-BE49-F238E27FC236}">
                        <a16:creationId xmlns:a16="http://schemas.microsoft.com/office/drawing/2014/main" id="{35664CB3-26E4-8F4B-8FB7-F2C2BB6DAA26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0" name="直線コネクタ 239">
                    <a:extLst>
                      <a:ext uri="{FF2B5EF4-FFF2-40B4-BE49-F238E27FC236}">
                        <a16:creationId xmlns:a16="http://schemas.microsoft.com/office/drawing/2014/main" id="{4BECBCF1-9FC2-8945-A29B-18C306A2AB57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05B09D44-15F7-FC45-95BB-24EF220BCF52}"/>
                  </a:ext>
                </a:extLst>
              </p:cNvPr>
              <p:cNvGrpSpPr/>
              <p:nvPr/>
            </p:nvGrpSpPr>
            <p:grpSpPr>
              <a:xfrm>
                <a:off x="1587536" y="5875640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228" name="テキスト ボックス 227">
                  <a:extLst>
                    <a:ext uri="{FF2B5EF4-FFF2-40B4-BE49-F238E27FC236}">
                      <a16:creationId xmlns:a16="http://schemas.microsoft.com/office/drawing/2014/main" id="{AC1104F0-09A6-4647-AF43-6AF6F4D88637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9" name="テキスト ボックス 228">
                  <a:extLst>
                    <a:ext uri="{FF2B5EF4-FFF2-40B4-BE49-F238E27FC236}">
                      <a16:creationId xmlns:a16="http://schemas.microsoft.com/office/drawing/2014/main" id="{DFDB80A1-A21F-FE41-8351-B3F1A8A89F88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0" name="テキスト ボックス 229">
                  <a:extLst>
                    <a:ext uri="{FF2B5EF4-FFF2-40B4-BE49-F238E27FC236}">
                      <a16:creationId xmlns:a16="http://schemas.microsoft.com/office/drawing/2014/main" id="{0BB1225C-CE96-9E43-9029-19F7B137308C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1" name="テキスト ボックス 230">
                  <a:extLst>
                    <a:ext uri="{FF2B5EF4-FFF2-40B4-BE49-F238E27FC236}">
                      <a16:creationId xmlns:a16="http://schemas.microsoft.com/office/drawing/2014/main" id="{FF90A98F-4EF7-5E46-9F0A-7A0BE8C4F062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2" name="テキスト ボックス 231">
                  <a:extLst>
                    <a:ext uri="{FF2B5EF4-FFF2-40B4-BE49-F238E27FC236}">
                      <a16:creationId xmlns:a16="http://schemas.microsoft.com/office/drawing/2014/main" id="{B4C2E154-C1BF-464F-9485-1B44204E323E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3" name="テキスト ボックス 232">
                  <a:extLst>
                    <a:ext uri="{FF2B5EF4-FFF2-40B4-BE49-F238E27FC236}">
                      <a16:creationId xmlns:a16="http://schemas.microsoft.com/office/drawing/2014/main" id="{951F4FAB-D46E-B64A-9956-A13E77BFDBCA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2FD101A2-77F6-4F49-A543-7D00E9B6A365}"/>
                </a:ext>
              </a:extLst>
            </p:cNvPr>
            <p:cNvSpPr txBox="1"/>
            <p:nvPr/>
          </p:nvSpPr>
          <p:spPr>
            <a:xfrm>
              <a:off x="10291704" y="565970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F925CADC-404B-484D-91B8-FA5BCEF2177C}"/>
                </a:ext>
              </a:extLst>
            </p:cNvPr>
            <p:cNvSpPr txBox="1"/>
            <p:nvPr/>
          </p:nvSpPr>
          <p:spPr>
            <a:xfrm>
              <a:off x="10291704" y="1556215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46040CA2-3171-E443-B2ED-7ABD5246D498}"/>
                </a:ext>
              </a:extLst>
            </p:cNvPr>
            <p:cNvSpPr txBox="1"/>
            <p:nvPr/>
          </p:nvSpPr>
          <p:spPr>
            <a:xfrm>
              <a:off x="10291577" y="2546462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テキスト ボックス 222">
              <a:extLst>
                <a:ext uri="{FF2B5EF4-FFF2-40B4-BE49-F238E27FC236}">
                  <a16:creationId xmlns:a16="http://schemas.microsoft.com/office/drawing/2014/main" id="{CC81C9D9-6B35-1543-B24F-5496BE1AD52E}"/>
                </a:ext>
              </a:extLst>
            </p:cNvPr>
            <p:cNvSpPr txBox="1"/>
            <p:nvPr/>
          </p:nvSpPr>
          <p:spPr>
            <a:xfrm>
              <a:off x="10291577" y="3536707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テキスト ボックス 223">
              <a:extLst>
                <a:ext uri="{FF2B5EF4-FFF2-40B4-BE49-F238E27FC236}">
                  <a16:creationId xmlns:a16="http://schemas.microsoft.com/office/drawing/2014/main" id="{79E0678F-F53A-D44D-BAD6-EDC45D7B3F7F}"/>
                </a:ext>
              </a:extLst>
            </p:cNvPr>
            <p:cNvSpPr txBox="1"/>
            <p:nvPr/>
          </p:nvSpPr>
          <p:spPr>
            <a:xfrm>
              <a:off x="10291577" y="4557695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テキスト ボックス 224">
              <a:extLst>
                <a:ext uri="{FF2B5EF4-FFF2-40B4-BE49-F238E27FC236}">
                  <a16:creationId xmlns:a16="http://schemas.microsoft.com/office/drawing/2014/main" id="{55E76B87-3D94-484E-B6AB-EC1F7A641F50}"/>
                </a:ext>
              </a:extLst>
            </p:cNvPr>
            <p:cNvSpPr txBox="1"/>
            <p:nvPr/>
          </p:nvSpPr>
          <p:spPr>
            <a:xfrm>
              <a:off x="10291577" y="5547940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59E03E0D-3F2D-2A43-97D6-26379D211081}"/>
              </a:ext>
            </a:extLst>
          </p:cNvPr>
          <p:cNvSpPr txBox="1"/>
          <p:nvPr/>
        </p:nvSpPr>
        <p:spPr>
          <a:xfrm rot="16200000">
            <a:off x="8550543" y="3216664"/>
            <a:ext cx="3246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11057583-9D56-D142-8F6F-167D97B8FA1D}"/>
              </a:ext>
            </a:extLst>
          </p:cNvPr>
          <p:cNvSpPr txBox="1"/>
          <p:nvPr/>
        </p:nvSpPr>
        <p:spPr>
          <a:xfrm>
            <a:off x="13839530" y="6135922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55" name="表 254">
            <a:extLst>
              <a:ext uri="{FF2B5EF4-FFF2-40B4-BE49-F238E27FC236}">
                <a16:creationId xmlns:a16="http://schemas.microsoft.com/office/drawing/2014/main" id="{9BD60187-A24D-084C-8959-D9830EA74D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3339033"/>
              </p:ext>
            </p:extLst>
          </p:nvPr>
        </p:nvGraphicFramePr>
        <p:xfrm>
          <a:off x="13533430" y="728655"/>
          <a:ext cx="4841178" cy="11254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3726">
                  <a:extLst>
                    <a:ext uri="{9D8B030D-6E8A-4147-A177-3AD203B41FA5}">
                      <a16:colId xmlns:a16="http://schemas.microsoft.com/office/drawing/2014/main" val="1701326281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927374419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394682298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vents/N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39234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2/608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–7.8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262382"/>
                  </a:ext>
                </a:extLst>
              </a:tr>
            </a:tbl>
          </a:graphicData>
        </a:graphic>
      </p:graphicFrame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F5F946EC-7C48-9242-9C01-07150B52077B}"/>
              </a:ext>
            </a:extLst>
          </p:cNvPr>
          <p:cNvSpPr txBox="1"/>
          <p:nvPr/>
        </p:nvSpPr>
        <p:spPr>
          <a:xfrm>
            <a:off x="10007061" y="6242401"/>
            <a:ext cx="800219" cy="64633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No. </a:t>
            </a:r>
          </a:p>
          <a:p>
            <a:r>
              <a:rPr kumimoji="1"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at risk</a:t>
            </a:r>
            <a:endParaRPr kumimoji="1"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FF107E38-6518-0647-8C49-2F3E410CCA95}"/>
              </a:ext>
            </a:extLst>
          </p:cNvPr>
          <p:cNvSpPr txBox="1"/>
          <p:nvPr/>
        </p:nvSpPr>
        <p:spPr>
          <a:xfrm>
            <a:off x="10680417" y="6461368"/>
            <a:ext cx="749024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608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722C7B81-94D4-6C47-A687-BE023BE5AF42}"/>
              </a:ext>
            </a:extLst>
          </p:cNvPr>
          <p:cNvSpPr txBox="1"/>
          <p:nvPr/>
        </p:nvSpPr>
        <p:spPr>
          <a:xfrm>
            <a:off x="12063409" y="6461369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167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テキスト ボックス 258">
            <a:extLst>
              <a:ext uri="{FF2B5EF4-FFF2-40B4-BE49-F238E27FC236}">
                <a16:creationId xmlns:a16="http://schemas.microsoft.com/office/drawing/2014/main" id="{E672BEFB-07B0-7E4B-ACD7-DF48787DCA82}"/>
              </a:ext>
            </a:extLst>
          </p:cNvPr>
          <p:cNvSpPr txBox="1"/>
          <p:nvPr/>
        </p:nvSpPr>
        <p:spPr>
          <a:xfrm>
            <a:off x="13563294" y="6461369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8D3A28D4-08F2-4A41-A204-A319CA90BF22}"/>
              </a:ext>
            </a:extLst>
          </p:cNvPr>
          <p:cNvSpPr txBox="1"/>
          <p:nvPr/>
        </p:nvSpPr>
        <p:spPr>
          <a:xfrm>
            <a:off x="15009219" y="6461369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0C446D55-E26D-4F4B-AB50-926246D38B06}"/>
              </a:ext>
            </a:extLst>
          </p:cNvPr>
          <p:cNvSpPr txBox="1"/>
          <p:nvPr/>
        </p:nvSpPr>
        <p:spPr>
          <a:xfrm>
            <a:off x="16455144" y="6461369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EC53E721-48C8-9E44-9926-5DE7058634D9}"/>
              </a:ext>
            </a:extLst>
          </p:cNvPr>
          <p:cNvSpPr txBox="1"/>
          <p:nvPr/>
        </p:nvSpPr>
        <p:spPr>
          <a:xfrm>
            <a:off x="17938533" y="6461369"/>
            <a:ext cx="907845" cy="3693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id="{59F13C1D-588A-7F4E-8A36-F151ECD95387}"/>
              </a:ext>
            </a:extLst>
          </p:cNvPr>
          <p:cNvSpPr txBox="1"/>
          <p:nvPr/>
        </p:nvSpPr>
        <p:spPr>
          <a:xfrm>
            <a:off x="10173044" y="78495"/>
            <a:ext cx="700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b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97" name="グループ化 96">
            <a:extLst>
              <a:ext uri="{FF2B5EF4-FFF2-40B4-BE49-F238E27FC236}">
                <a16:creationId xmlns:a16="http://schemas.microsoft.com/office/drawing/2014/main" id="{01C5CA58-92A2-5244-B3CF-8CCB766E2792}"/>
              </a:ext>
            </a:extLst>
          </p:cNvPr>
          <p:cNvGrpSpPr/>
          <p:nvPr/>
        </p:nvGrpSpPr>
        <p:grpSpPr>
          <a:xfrm>
            <a:off x="1169870" y="7259729"/>
            <a:ext cx="8554801" cy="5685588"/>
            <a:chOff x="1198696" y="559386"/>
            <a:chExt cx="8554801" cy="5685588"/>
          </a:xfrm>
        </p:grpSpPr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A84CAE30-7989-F44F-BC74-AF348C24E4AC}"/>
                </a:ext>
              </a:extLst>
            </p:cNvPr>
            <p:cNvGrpSpPr/>
            <p:nvPr/>
          </p:nvGrpSpPr>
          <p:grpSpPr>
            <a:xfrm>
              <a:off x="1587536" y="728662"/>
              <a:ext cx="8165961" cy="5516312"/>
              <a:chOff x="1587536" y="728662"/>
              <a:chExt cx="8165961" cy="5516312"/>
            </a:xfrm>
          </p:grpSpPr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AF6AA4D3-DF44-FB4D-92C4-D261C6CC6782}"/>
                  </a:ext>
                </a:extLst>
              </p:cNvPr>
              <p:cNvGrpSpPr/>
              <p:nvPr/>
            </p:nvGrpSpPr>
            <p:grpSpPr>
              <a:xfrm>
                <a:off x="1856217" y="728662"/>
                <a:ext cx="7699076" cy="5100637"/>
                <a:chOff x="1878266" y="783771"/>
                <a:chExt cx="6812280" cy="4520862"/>
              </a:xfrm>
            </p:grpSpPr>
            <p:grpSp>
              <p:nvGrpSpPr>
                <p:cNvPr id="113" name="グループ化 112">
                  <a:extLst>
                    <a:ext uri="{FF2B5EF4-FFF2-40B4-BE49-F238E27FC236}">
                      <a16:creationId xmlns:a16="http://schemas.microsoft.com/office/drawing/2014/main" id="{52A6EEF4-5E6E-DD47-967E-E53AF05144E9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6812280" cy="4520862"/>
                  <a:chOff x="1878266" y="776087"/>
                  <a:chExt cx="6812280" cy="4520862"/>
                </a:xfrm>
              </p:grpSpPr>
              <p:cxnSp>
                <p:nvCxnSpPr>
                  <p:cNvPr id="120" name="直線コネクタ 119">
                    <a:extLst>
                      <a:ext uri="{FF2B5EF4-FFF2-40B4-BE49-F238E27FC236}">
                        <a16:creationId xmlns:a16="http://schemas.microsoft.com/office/drawing/2014/main" id="{C009B549-3231-DE4B-83F3-AA7FE05F9C08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5170949"/>
                    <a:ext cx="6812280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直線コネクタ 120">
                    <a:extLst>
                      <a:ext uri="{FF2B5EF4-FFF2-40B4-BE49-F238E27FC236}">
                        <a16:creationId xmlns:a16="http://schemas.microsoft.com/office/drawing/2014/main" id="{1725C10D-D456-F846-80C1-0BA905FC6A9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82481" y="776087"/>
                    <a:ext cx="0" cy="4520862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直線コネクタ 121">
                    <a:extLst>
                      <a:ext uri="{FF2B5EF4-FFF2-40B4-BE49-F238E27FC236}">
                        <a16:creationId xmlns:a16="http://schemas.microsoft.com/office/drawing/2014/main" id="{1C5F0FE9-37EC-1245-894B-E2D3318C4906}"/>
                      </a:ext>
                    </a:extLst>
                  </p:cNvPr>
                  <p:cNvCxnSpPr/>
                  <p:nvPr/>
                </p:nvCxnSpPr>
                <p:spPr>
                  <a:xfrm>
                    <a:off x="2631047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直線コネクタ 122">
                    <a:extLst>
                      <a:ext uri="{FF2B5EF4-FFF2-40B4-BE49-F238E27FC236}">
                        <a16:creationId xmlns:a16="http://schemas.microsoft.com/office/drawing/2014/main" id="{6C941A2D-0023-4442-9468-FF11374C1F20}"/>
                      </a:ext>
                    </a:extLst>
                  </p:cNvPr>
                  <p:cNvCxnSpPr/>
                  <p:nvPr/>
                </p:nvCxnSpPr>
                <p:spPr>
                  <a:xfrm>
                    <a:off x="3279613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直線コネクタ 123">
                    <a:extLst>
                      <a:ext uri="{FF2B5EF4-FFF2-40B4-BE49-F238E27FC236}">
                        <a16:creationId xmlns:a16="http://schemas.microsoft.com/office/drawing/2014/main" id="{E467C671-5526-5F40-A9CF-1DBA22F120AC}"/>
                      </a:ext>
                    </a:extLst>
                  </p:cNvPr>
                  <p:cNvCxnSpPr/>
                  <p:nvPr/>
                </p:nvCxnSpPr>
                <p:spPr>
                  <a:xfrm>
                    <a:off x="3928179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直線コネクタ 124">
                    <a:extLst>
                      <a:ext uri="{FF2B5EF4-FFF2-40B4-BE49-F238E27FC236}">
                        <a16:creationId xmlns:a16="http://schemas.microsoft.com/office/drawing/2014/main" id="{73169662-BBD3-1442-9934-990D7887B640}"/>
                      </a:ext>
                    </a:extLst>
                  </p:cNvPr>
                  <p:cNvCxnSpPr/>
                  <p:nvPr/>
                </p:nvCxnSpPr>
                <p:spPr>
                  <a:xfrm>
                    <a:off x="4576745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直線コネクタ 125">
                    <a:extLst>
                      <a:ext uri="{FF2B5EF4-FFF2-40B4-BE49-F238E27FC236}">
                        <a16:creationId xmlns:a16="http://schemas.microsoft.com/office/drawing/2014/main" id="{86FAD5A2-1787-0541-B871-1E73AC72AC7E}"/>
                      </a:ext>
                    </a:extLst>
                  </p:cNvPr>
                  <p:cNvCxnSpPr/>
                  <p:nvPr/>
                </p:nvCxnSpPr>
                <p:spPr>
                  <a:xfrm>
                    <a:off x="5225312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7" name="直線コネクタ 126">
                    <a:extLst>
                      <a:ext uri="{FF2B5EF4-FFF2-40B4-BE49-F238E27FC236}">
                        <a16:creationId xmlns:a16="http://schemas.microsoft.com/office/drawing/2014/main" id="{1C84A4EE-6DA3-0441-AAFF-2433C2E130F4}"/>
                      </a:ext>
                    </a:extLst>
                  </p:cNvPr>
                  <p:cNvCxnSpPr/>
                  <p:nvPr/>
                </p:nvCxnSpPr>
                <p:spPr>
                  <a:xfrm>
                    <a:off x="65224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8" name="直線コネクタ 127">
                    <a:extLst>
                      <a:ext uri="{FF2B5EF4-FFF2-40B4-BE49-F238E27FC236}">
                        <a16:creationId xmlns:a16="http://schemas.microsoft.com/office/drawing/2014/main" id="{BC221ED4-B68E-8F48-907F-16702BECBD39}"/>
                      </a:ext>
                    </a:extLst>
                  </p:cNvPr>
                  <p:cNvCxnSpPr/>
                  <p:nvPr/>
                </p:nvCxnSpPr>
                <p:spPr>
                  <a:xfrm>
                    <a:off x="5873878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9" name="直線コネクタ 128">
                    <a:extLst>
                      <a:ext uri="{FF2B5EF4-FFF2-40B4-BE49-F238E27FC236}">
                        <a16:creationId xmlns:a16="http://schemas.microsoft.com/office/drawing/2014/main" id="{240A3A48-9CC7-0040-BE32-EDD08546783C}"/>
                      </a:ext>
                    </a:extLst>
                  </p:cNvPr>
                  <p:cNvCxnSpPr/>
                  <p:nvPr/>
                </p:nvCxnSpPr>
                <p:spPr>
                  <a:xfrm>
                    <a:off x="7171010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0" name="直線コネクタ 129">
                    <a:extLst>
                      <a:ext uri="{FF2B5EF4-FFF2-40B4-BE49-F238E27FC236}">
                        <a16:creationId xmlns:a16="http://schemas.microsoft.com/office/drawing/2014/main" id="{660303A6-C6BA-DA46-BDD3-CBA864431038}"/>
                      </a:ext>
                    </a:extLst>
                  </p:cNvPr>
                  <p:cNvCxnSpPr/>
                  <p:nvPr/>
                </p:nvCxnSpPr>
                <p:spPr>
                  <a:xfrm>
                    <a:off x="8468144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1" name="直線コネクタ 130">
                    <a:extLst>
                      <a:ext uri="{FF2B5EF4-FFF2-40B4-BE49-F238E27FC236}">
                        <a16:creationId xmlns:a16="http://schemas.microsoft.com/office/drawing/2014/main" id="{66A69E30-E7AA-054D-B678-D7215DD22D29}"/>
                      </a:ext>
                    </a:extLst>
                  </p:cNvPr>
                  <p:cNvCxnSpPr/>
                  <p:nvPr/>
                </p:nvCxnSpPr>
                <p:spPr>
                  <a:xfrm>
                    <a:off x="7819576" y="5170949"/>
                    <a:ext cx="0" cy="12600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14" name="グループ化 113">
                  <a:extLst>
                    <a:ext uri="{FF2B5EF4-FFF2-40B4-BE49-F238E27FC236}">
                      <a16:creationId xmlns:a16="http://schemas.microsoft.com/office/drawing/2014/main" id="{7428C6AC-9557-1249-858D-88263780C0A9}"/>
                    </a:ext>
                  </a:extLst>
                </p:cNvPr>
                <p:cNvGrpSpPr/>
                <p:nvPr/>
              </p:nvGrpSpPr>
              <p:grpSpPr>
                <a:xfrm>
                  <a:off x="1878266" y="783771"/>
                  <a:ext cx="104215" cy="3510752"/>
                  <a:chOff x="1878266" y="783771"/>
                  <a:chExt cx="104215" cy="3510752"/>
                </a:xfrm>
              </p:grpSpPr>
              <p:cxnSp>
                <p:nvCxnSpPr>
                  <p:cNvPr id="115" name="直線コネクタ 114">
                    <a:extLst>
                      <a:ext uri="{FF2B5EF4-FFF2-40B4-BE49-F238E27FC236}">
                        <a16:creationId xmlns:a16="http://schemas.microsoft.com/office/drawing/2014/main" id="{35BCDA50-812B-2443-9FF1-0737B2064122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783771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直線コネクタ 115">
                    <a:extLst>
                      <a:ext uri="{FF2B5EF4-FFF2-40B4-BE49-F238E27FC236}">
                        <a16:creationId xmlns:a16="http://schemas.microsoft.com/office/drawing/2014/main" id="{5236D2F9-53FA-4A44-A88F-7A16E6709EDF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1661459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直線コネクタ 116">
                    <a:extLst>
                      <a:ext uri="{FF2B5EF4-FFF2-40B4-BE49-F238E27FC236}">
                        <a16:creationId xmlns:a16="http://schemas.microsoft.com/office/drawing/2014/main" id="{C8D2D68F-C245-1E49-AD67-97AFF83E6462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2539147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直線コネクタ 117">
                    <a:extLst>
                      <a:ext uri="{FF2B5EF4-FFF2-40B4-BE49-F238E27FC236}">
                        <a16:creationId xmlns:a16="http://schemas.microsoft.com/office/drawing/2014/main" id="{FF79C11A-EBC2-1441-BE4E-7BE0829966F6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4294523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直線コネクタ 118">
                    <a:extLst>
                      <a:ext uri="{FF2B5EF4-FFF2-40B4-BE49-F238E27FC236}">
                        <a16:creationId xmlns:a16="http://schemas.microsoft.com/office/drawing/2014/main" id="{9CD1B344-6956-E246-9432-8EC5965A2C17}"/>
                      </a:ext>
                    </a:extLst>
                  </p:cNvPr>
                  <p:cNvCxnSpPr/>
                  <p:nvPr/>
                </p:nvCxnSpPr>
                <p:spPr>
                  <a:xfrm>
                    <a:off x="1878266" y="3416835"/>
                    <a:ext cx="104215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106" name="グループ化 105">
                <a:extLst>
                  <a:ext uri="{FF2B5EF4-FFF2-40B4-BE49-F238E27FC236}">
                    <a16:creationId xmlns:a16="http://schemas.microsoft.com/office/drawing/2014/main" id="{791D270C-652E-8D44-A5F5-4379BA77EAA6}"/>
                  </a:ext>
                </a:extLst>
              </p:cNvPr>
              <p:cNvGrpSpPr/>
              <p:nvPr/>
            </p:nvGrpSpPr>
            <p:grpSpPr>
              <a:xfrm>
                <a:off x="1587536" y="5875641"/>
                <a:ext cx="8165961" cy="369333"/>
                <a:chOff x="-18297497" y="9356492"/>
                <a:chExt cx="16311128" cy="737728"/>
              </a:xfrm>
            </p:grpSpPr>
            <p:sp>
              <p:nvSpPr>
                <p:cNvPr id="107" name="テキスト ボックス 106">
                  <a:extLst>
                    <a:ext uri="{FF2B5EF4-FFF2-40B4-BE49-F238E27FC236}">
                      <a16:creationId xmlns:a16="http://schemas.microsoft.com/office/drawing/2014/main" id="{8E0E5E08-4EF4-4742-816D-7DFE37F69100}"/>
                    </a:ext>
                  </a:extLst>
                </p:cNvPr>
                <p:cNvSpPr txBox="1"/>
                <p:nvPr/>
              </p:nvSpPr>
              <p:spPr>
                <a:xfrm>
                  <a:off x="-18297497" y="9356494"/>
                  <a:ext cx="1496141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テキスト ボックス 107">
                  <a:extLst>
                    <a:ext uri="{FF2B5EF4-FFF2-40B4-BE49-F238E27FC236}">
                      <a16:creationId xmlns:a16="http://schemas.microsoft.com/office/drawing/2014/main" id="{A4F12580-7DFD-CC49-B40F-611805A52AE2}"/>
                    </a:ext>
                  </a:extLst>
                </p:cNvPr>
                <p:cNvSpPr txBox="1"/>
                <p:nvPr/>
              </p:nvSpPr>
              <p:spPr>
                <a:xfrm>
                  <a:off x="-15535035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9" name="テキスト ボックス 108">
                  <a:extLst>
                    <a:ext uri="{FF2B5EF4-FFF2-40B4-BE49-F238E27FC236}">
                      <a16:creationId xmlns:a16="http://schemas.microsoft.com/office/drawing/2014/main" id="{6F36BFFD-0DCF-9D41-9C05-14208EEAC066}"/>
                    </a:ext>
                  </a:extLst>
                </p:cNvPr>
                <p:cNvSpPr txBox="1"/>
                <p:nvPr/>
              </p:nvSpPr>
              <p:spPr>
                <a:xfrm>
                  <a:off x="-12539084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4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テキスト ボックス 109">
                  <a:extLst>
                    <a:ext uri="{FF2B5EF4-FFF2-40B4-BE49-F238E27FC236}">
                      <a16:creationId xmlns:a16="http://schemas.microsoft.com/office/drawing/2014/main" id="{158D7564-D6E1-ED4F-9A8C-064071261A26}"/>
                    </a:ext>
                  </a:extLst>
                </p:cNvPr>
                <p:cNvSpPr txBox="1"/>
                <p:nvPr/>
              </p:nvSpPr>
              <p:spPr>
                <a:xfrm>
                  <a:off x="-9650916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6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1" name="テキスト ボックス 110">
                  <a:extLst>
                    <a:ext uri="{FF2B5EF4-FFF2-40B4-BE49-F238E27FC236}">
                      <a16:creationId xmlns:a16="http://schemas.microsoft.com/office/drawing/2014/main" id="{9B2BEC0E-A46F-554A-8522-5729A8750A85}"/>
                    </a:ext>
                  </a:extLst>
                </p:cNvPr>
                <p:cNvSpPr txBox="1"/>
                <p:nvPr/>
              </p:nvSpPr>
              <p:spPr>
                <a:xfrm>
                  <a:off x="-6762748" y="9356494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8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2" name="テキスト ボックス 111">
                  <a:extLst>
                    <a:ext uri="{FF2B5EF4-FFF2-40B4-BE49-F238E27FC236}">
                      <a16:creationId xmlns:a16="http://schemas.microsoft.com/office/drawing/2014/main" id="{77EECC0E-41D1-1548-9107-D89921C6278F}"/>
                    </a:ext>
                  </a:extLst>
                </p:cNvPr>
                <p:cNvSpPr txBox="1"/>
                <p:nvPr/>
              </p:nvSpPr>
              <p:spPr>
                <a:xfrm>
                  <a:off x="-3799747" y="9356492"/>
                  <a:ext cx="1813378" cy="7377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1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  <a:endParaRPr lang="ja-JP" altLang="en-US" sz="1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6A5E0243-9658-0842-B9DE-77CF4FD3C436}"/>
                </a:ext>
              </a:extLst>
            </p:cNvPr>
            <p:cNvSpPr txBox="1"/>
            <p:nvPr/>
          </p:nvSpPr>
          <p:spPr>
            <a:xfrm>
              <a:off x="1198823" y="55938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532AA6BA-B551-CB40-A11C-E3BEC849451D}"/>
                </a:ext>
              </a:extLst>
            </p:cNvPr>
            <p:cNvSpPr txBox="1"/>
            <p:nvPr/>
          </p:nvSpPr>
          <p:spPr>
            <a:xfrm>
              <a:off x="1198823" y="154963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B0B63E8A-F3DD-9D4E-9C5A-CCC62F89F46F}"/>
                </a:ext>
              </a:extLst>
            </p:cNvPr>
            <p:cNvSpPr txBox="1"/>
            <p:nvPr/>
          </p:nvSpPr>
          <p:spPr>
            <a:xfrm>
              <a:off x="1198696" y="2539878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753F9C21-DAD8-6F4F-A7DC-014E886E3004}"/>
                </a:ext>
              </a:extLst>
            </p:cNvPr>
            <p:cNvSpPr txBox="1"/>
            <p:nvPr/>
          </p:nvSpPr>
          <p:spPr>
            <a:xfrm>
              <a:off x="1198696" y="3530123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B4A7EE48-FC3D-AA40-B845-21F3FF21A812}"/>
                </a:ext>
              </a:extLst>
            </p:cNvPr>
            <p:cNvSpPr txBox="1"/>
            <p:nvPr/>
          </p:nvSpPr>
          <p:spPr>
            <a:xfrm>
              <a:off x="1198696" y="4551111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9547DC66-2BD7-B247-BC48-7B844FCB80F9}"/>
                </a:ext>
              </a:extLst>
            </p:cNvPr>
            <p:cNvSpPr txBox="1"/>
            <p:nvPr/>
          </p:nvSpPr>
          <p:spPr>
            <a:xfrm>
              <a:off x="1198696" y="5541356"/>
              <a:ext cx="57724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ja-JP" altLang="en-US" sz="1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BE28FD49-608B-7441-BA88-D951439E1CDF}"/>
              </a:ext>
            </a:extLst>
          </p:cNvPr>
          <p:cNvSpPr txBox="1"/>
          <p:nvPr/>
        </p:nvSpPr>
        <p:spPr>
          <a:xfrm rot="16200000">
            <a:off x="-429900" y="9750714"/>
            <a:ext cx="30014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Post-progression survival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2C5A3509-5845-2844-B93C-F25A5808D004}"/>
              </a:ext>
            </a:extLst>
          </p:cNvPr>
          <p:cNvSpPr txBox="1"/>
          <p:nvPr/>
        </p:nvSpPr>
        <p:spPr>
          <a:xfrm>
            <a:off x="4717823" y="12829681"/>
            <a:ext cx="2530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lang="ja-JP" altLang="en-US" sz="1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4" name="表 133">
            <a:extLst>
              <a:ext uri="{FF2B5EF4-FFF2-40B4-BE49-F238E27FC236}">
                <a16:creationId xmlns:a16="http://schemas.microsoft.com/office/drawing/2014/main" id="{575588FA-0A19-AD45-85CF-A501F9AC4B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59150692"/>
              </p:ext>
            </p:extLst>
          </p:nvPr>
        </p:nvGraphicFramePr>
        <p:xfrm>
          <a:off x="4651288" y="7444395"/>
          <a:ext cx="4841178" cy="112544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3726">
                  <a:extLst>
                    <a:ext uri="{9D8B030D-6E8A-4147-A177-3AD203B41FA5}">
                      <a16:colId xmlns:a16="http://schemas.microsoft.com/office/drawing/2014/main" val="1701326281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927374419"/>
                    </a:ext>
                  </a:extLst>
                </a:gridCol>
                <a:gridCol w="1613726">
                  <a:extLst>
                    <a:ext uri="{9D8B030D-6E8A-4147-A177-3AD203B41FA5}">
                      <a16:colId xmlns:a16="http://schemas.microsoft.com/office/drawing/2014/main" val="394682298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/N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</a:t>
                      </a:r>
                    </a:p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onths)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CI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5392341"/>
                  </a:ext>
                </a:extLst>
              </a:tr>
              <a:tr h="4853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5/552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</a:t>
                      </a:r>
                      <a:endParaRPr kumimoji="1" lang="ja-JP" altLang="en-US" sz="1800" b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–8.2</a:t>
                      </a:r>
                      <a:endParaRPr kumimoji="1" lang="ja-JP" altLang="en-US" sz="18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2262382"/>
                  </a:ext>
                </a:extLst>
              </a:tr>
            </a:tbl>
          </a:graphicData>
        </a:graphic>
      </p:graphicFrame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3CAAF06F-555E-7141-ABBD-68BC359E46E6}"/>
              </a:ext>
            </a:extLst>
          </p:cNvPr>
          <p:cNvSpPr txBox="1"/>
          <p:nvPr/>
        </p:nvSpPr>
        <p:spPr>
          <a:xfrm>
            <a:off x="1185823" y="6878946"/>
            <a:ext cx="700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c</a:t>
            </a:r>
            <a:endParaRPr kumimoji="1" lang="ja-JP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277040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BRACELET Study 1">
      <a:dk1>
        <a:srgbClr val="000000"/>
      </a:dk1>
      <a:lt1>
        <a:srgbClr val="FFFFFF"/>
      </a:lt1>
      <a:dk2>
        <a:srgbClr val="454551"/>
      </a:dk2>
      <a:lt2>
        <a:srgbClr val="D8D9DC"/>
      </a:lt2>
      <a:accent1>
        <a:srgbClr val="E8003E"/>
      </a:accent1>
      <a:accent2>
        <a:srgbClr val="C830CC"/>
      </a:accent2>
      <a:accent3>
        <a:srgbClr val="4EA6DC"/>
      </a:accent3>
      <a:accent4>
        <a:srgbClr val="00559B"/>
      </a:accent4>
      <a:accent5>
        <a:srgbClr val="8971E1"/>
      </a:accent5>
      <a:accent6>
        <a:srgbClr val="D54773"/>
      </a:accent6>
      <a:hlink>
        <a:srgbClr val="B30658"/>
      </a:hlink>
      <a:folHlink>
        <a:srgbClr val="00559B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JOG13219G template" id="{C2A2FF71-2FFF-A542-8AB3-4CC5D1F2FF7E}" vid="{84F2038F-6506-2841-81A3-3FBB7B3A4003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4</TotalTime>
  <Words>132</Words>
  <Application>Microsoft Macintosh PowerPoint</Application>
  <PresentationFormat>ユーザー設定</PresentationFormat>
  <Paragraphs>8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1_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嵜 啓太郎</dc:creator>
  <cp:lastModifiedBy>下嵜啓太郎</cp:lastModifiedBy>
  <cp:revision>211</cp:revision>
  <cp:lastPrinted>2021-03-12T09:49:31Z</cp:lastPrinted>
  <dcterms:created xsi:type="dcterms:W3CDTF">2021-02-06T04:10:30Z</dcterms:created>
  <dcterms:modified xsi:type="dcterms:W3CDTF">2021-06-17T05:26:48Z</dcterms:modified>
</cp:coreProperties>
</file>